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56" r:id="rId3"/>
    <p:sldId id="257" r:id="rId4"/>
    <p:sldId id="267" r:id="rId5"/>
    <p:sldId id="258" r:id="rId6"/>
    <p:sldId id="265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/>
    <p:restoredTop sz="94676"/>
  </p:normalViewPr>
  <p:slideViewPr>
    <p:cSldViewPr snapToGrid="0" snapToObjects="1">
      <p:cViewPr varScale="1">
        <p:scale>
          <a:sx n="95" d="100"/>
          <a:sy n="95" d="100"/>
        </p:scale>
        <p:origin x="208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E313C8-5CC8-A040-A318-D032589FAC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8E6674-D48A-284C-BC6E-6A86954B28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C5CAA4-0829-F346-A460-3DA0363A8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9F2B91-3314-694D-A03E-D43D5C119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F56AE8-4CBA-0B45-ADBC-123D3C4B4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258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2E10A-6F7A-0A4F-A417-D4BD921468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64F73D-1E1D-514A-8CF8-0E1545941C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5507C9-1AB9-E646-98F7-F67EFA015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3C2E50-AF77-1B4A-B5AD-9985E4AC2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012604-781E-3940-ABBE-8DE7E86FB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49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414314-AAF9-7947-AE55-903D71DFE5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521823-0F6F-F348-8FF1-AEE035B7C3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20127-810D-9B44-93F6-805F44108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66A0B2-9BD0-3448-B005-87B162A74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12148-184E-4A47-A75F-E770B47DC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775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721757-06E1-0749-B90B-E38C424CB5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3760AF-C723-5942-B4DA-B9D73C7EAB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303D1C-109C-D348-928D-44A501A32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51991-B3C6-5540-BF07-DED35577A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B0E32-6ED6-AD45-BFEA-4CC44B6F9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311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CB80D8-DF3D-7E41-9170-525543BD0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25DDFE-CA4C-F24A-979A-6C30EAD1AE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ED334D-1532-6C4C-B8BE-3CD328195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15DB17-BC52-4F44-B65D-69DC6A5AA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B83397-4BCF-7641-8166-067828D82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683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111D6-247B-264E-BA5B-2ED2CD6971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687FD5-3D18-634E-96B9-03C601A4FD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D21D9D-3D4D-1B41-9D72-DCF3EEA57C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AE8A10-817B-634D-9463-4037A46C0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CD7705-C5F5-694B-8E7E-9F7A0AF48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6AB146-08E1-A941-A2F8-077A92B6D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609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FC027D-D490-5C41-89B2-6C676FE85D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2BFC86-D866-F841-868D-086079F4BD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087EDD-0627-5D4F-88F2-50412F6DA2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A31006-B0C3-1B40-839B-6469BB9206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7C518D-882C-AD46-81E1-BA07E3F4A0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91A2B3-0DEB-FC4A-9925-46D17D8FD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DA4677-15E3-0A4C-8A5C-A9B7E73C6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9AFE8C-D268-504C-ABFD-0873F863D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212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1ACCA0-55EF-BD43-A5CE-960F85AD4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8D6894-D490-C945-969C-6CBE3BF91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803464-06B9-8741-8CF2-5C3CA35FB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F27D27-B559-0F47-8EC5-43D0423F5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020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D9EEB7-C088-584E-8EC8-6143524F0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5B73A5-AAB2-DB48-A90D-18E93F731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36D6F4-5FBA-3740-8222-3AB03F4B3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450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80293-034E-2A4B-8067-5881EDAB1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4D2C5A-4163-D14D-8467-6074DBA62A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E79F15-0056-2043-AAE6-0E9BE39AB1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7EC10-95FF-2D45-96B3-BF91E01BE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1CEA45-1219-2F44-93D0-E015218DD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E763BB-8245-504B-92ED-69B49C848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2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9D35E-11E2-BD47-8C42-628E5F5D9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8B534E-24D4-E843-AED6-28BF13E578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AD90FB-AEE7-3D43-862E-040C136969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F32D8F-6043-D94C-979A-24100C6C9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778BC-EEA0-F048-B969-D648E4F83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A36033-13C0-C346-A188-88C8361F9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368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58E891-5E8E-ED4B-8E42-568E3ADD5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4799D1-C44F-3545-A0F1-6628D6675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CB0D4B-10EE-8542-8586-BC16931480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A308A-A5D1-0847-A7AC-3FD32145DD96}" type="datetimeFigureOut">
              <a:rPr lang="en-US" smtClean="0"/>
              <a:t>4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8F84A-FB33-CA41-8AC9-F688E1EC0A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0AC98E-6319-6D4C-9610-C529BE9FBA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F8EEAB-D353-F14A-AF25-6A34D22AC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96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75930FB-9BAD-7E47-8B30-6D6D43425A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1526" y="1070536"/>
            <a:ext cx="4254502" cy="425450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89A3070-211A-E645-B506-1632DA8CD281}"/>
              </a:ext>
            </a:extLst>
          </p:cNvPr>
          <p:cNvSpPr txBox="1"/>
          <p:nvPr/>
        </p:nvSpPr>
        <p:spPr>
          <a:xfrm>
            <a:off x="1394122" y="5384132"/>
            <a:ext cx="91956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. Selection of single cell RNA-seq data available through the </a:t>
            </a:r>
            <a:r>
              <a:rPr lang="en-US" sz="1200" b="1" i="1" dirty="0"/>
              <a:t>Tabula </a:t>
            </a:r>
            <a:r>
              <a:rPr lang="en-US" sz="1200" b="1" i="1" dirty="0" err="1"/>
              <a:t>Muris</a:t>
            </a:r>
            <a:r>
              <a:rPr lang="en-US" sz="1200" b="1" i="1" dirty="0"/>
              <a:t> </a:t>
            </a:r>
            <a:r>
              <a:rPr lang="en-US" sz="1200" b="1" dirty="0"/>
              <a:t>Compendium. a)</a:t>
            </a:r>
            <a:r>
              <a:rPr lang="en-US" sz="1200" dirty="0"/>
              <a:t> Tissue, cell type and number of cells sequenced for data queried. Only tissues and cell types with &gt;70 cells sequenced were included in the analyses. </a:t>
            </a:r>
            <a:r>
              <a:rPr lang="en-US" sz="1200" b="1" dirty="0"/>
              <a:t>b) </a:t>
            </a:r>
            <a:r>
              <a:rPr lang="en-US" sz="1200" dirty="0"/>
              <a:t>PCA analysis of tissue/cell type expression reveals a positive correlation between PC2 and endothelial cell type expression.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C7E599C-40DD-804B-A0D3-208E61D1D4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4323164"/>
              </p:ext>
            </p:extLst>
          </p:nvPr>
        </p:nvGraphicFramePr>
        <p:xfrm>
          <a:off x="1699448" y="1491277"/>
          <a:ext cx="4058802" cy="362566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52934">
                  <a:extLst>
                    <a:ext uri="{9D8B030D-6E8A-4147-A177-3AD203B41FA5}">
                      <a16:colId xmlns:a16="http://schemas.microsoft.com/office/drawing/2014/main" val="8939952"/>
                    </a:ext>
                  </a:extLst>
                </a:gridCol>
                <a:gridCol w="1352934">
                  <a:extLst>
                    <a:ext uri="{9D8B030D-6E8A-4147-A177-3AD203B41FA5}">
                      <a16:colId xmlns:a16="http://schemas.microsoft.com/office/drawing/2014/main" val="1198296481"/>
                    </a:ext>
                  </a:extLst>
                </a:gridCol>
                <a:gridCol w="1352934">
                  <a:extLst>
                    <a:ext uri="{9D8B030D-6E8A-4147-A177-3AD203B41FA5}">
                      <a16:colId xmlns:a16="http://schemas.microsoft.com/office/drawing/2014/main" val="3314980049"/>
                    </a:ext>
                  </a:extLst>
                </a:gridCol>
              </a:tblGrid>
              <a:tr h="2284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Tiss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ell typ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# cells sequence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663060874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Lu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ndothelial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9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419931924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a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ndocardial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829301423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Aor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ndothelial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2863896639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a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ndothelial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7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021865239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a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cardiac muscle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045274723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Aor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rythrocy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3286246009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Lu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pithelial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258110967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Lu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classical monocy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2750527301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Lu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yeloid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392563249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a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leukocy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2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1963510871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a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yofibroblast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4035469894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Lu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tromal c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2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2882141596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a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fibrobla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1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540053165"/>
                  </a:ext>
                </a:extLst>
              </a:tr>
              <a:tr h="2426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Aor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fibrobla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671" marR="8671" marT="8671" marB="0" anchor="b"/>
                </a:tc>
                <a:extLst>
                  <a:ext uri="{0D108BD9-81ED-4DB2-BD59-A6C34878D82A}">
                    <a16:rowId xmlns:a16="http://schemas.microsoft.com/office/drawing/2014/main" val="339175340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6D79874-7148-674A-9505-D23CDF6990B6}"/>
              </a:ext>
            </a:extLst>
          </p:cNvPr>
          <p:cNvSpPr txBox="1"/>
          <p:nvPr/>
        </p:nvSpPr>
        <p:spPr>
          <a:xfrm>
            <a:off x="1433001" y="1076069"/>
            <a:ext cx="3080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6D22B21-9EA2-7B4A-8EEC-B2EE61BE49AB}"/>
              </a:ext>
            </a:extLst>
          </p:cNvPr>
          <p:cNvSpPr txBox="1"/>
          <p:nvPr/>
        </p:nvSpPr>
        <p:spPr>
          <a:xfrm>
            <a:off x="5916442" y="107606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854507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18EDD0A-0F9B-554D-B99F-3788A07D96B9}"/>
              </a:ext>
            </a:extLst>
          </p:cNvPr>
          <p:cNvSpPr txBox="1"/>
          <p:nvPr/>
        </p:nvSpPr>
        <p:spPr>
          <a:xfrm>
            <a:off x="1923800" y="5998093"/>
            <a:ext cx="80633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S2. Gene-level burden test for rare synonymous variants using 2789 European PAH cases and 18,819 European controls (11,101 SPARK parents, 7718 NFE </a:t>
            </a:r>
            <a:r>
              <a:rPr lang="en-US" sz="1200" b="1" dirty="0" err="1"/>
              <a:t>gnomAD</a:t>
            </a:r>
            <a:r>
              <a:rPr lang="en-US" sz="1200" b="1" dirty="0"/>
              <a:t> v2.1.1).</a:t>
            </a:r>
            <a:r>
              <a:rPr lang="en-US" sz="1200" dirty="0"/>
              <a:t> Results of a binomial test confined to rare synonymous variants in 20,000 protein-coding genes.</a:t>
            </a:r>
          </a:p>
        </p:txBody>
      </p:sp>
      <p:pic>
        <p:nvPicPr>
          <p:cNvPr id="6" name="Content Placeholder 10">
            <a:extLst>
              <a:ext uri="{FF2B5EF4-FFF2-40B4-BE49-F238E27FC236}">
                <a16:creationId xmlns:a16="http://schemas.microsoft.com/office/drawing/2014/main" id="{54F5C17E-67C0-BB4B-B2F6-1260BBC2A1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1315" y="1247499"/>
            <a:ext cx="4972319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2953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9BA55922-5835-2647-9D71-DE04A3DB9CE3}"/>
              </a:ext>
            </a:extLst>
          </p:cNvPr>
          <p:cNvGrpSpPr/>
          <p:nvPr/>
        </p:nvGrpSpPr>
        <p:grpSpPr>
          <a:xfrm>
            <a:off x="989283" y="922622"/>
            <a:ext cx="3650227" cy="3507693"/>
            <a:chOff x="931856" y="2011829"/>
            <a:chExt cx="3801783" cy="380178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260659A-0B6F-7B4A-9B95-48A1C15FB0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1856" y="2011829"/>
              <a:ext cx="3801783" cy="3801783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D1D051AA-64FD-104D-B026-5BC6AEA26D21}"/>
                </a:ext>
              </a:extLst>
            </p:cNvPr>
            <p:cNvSpPr/>
            <p:nvPr/>
          </p:nvSpPr>
          <p:spPr>
            <a:xfrm>
              <a:off x="1842247" y="2145815"/>
              <a:ext cx="2205318" cy="1939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3DCB6E91-47BE-294B-94A2-57AA1C9A4C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2899120"/>
              </p:ext>
            </p:extLst>
          </p:nvPr>
        </p:nvGraphicFramePr>
        <p:xfrm>
          <a:off x="5024805" y="1115341"/>
          <a:ext cx="5764911" cy="430906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82752">
                  <a:extLst>
                    <a:ext uri="{9D8B030D-6E8A-4147-A177-3AD203B41FA5}">
                      <a16:colId xmlns:a16="http://schemas.microsoft.com/office/drawing/2014/main" val="406484733"/>
                    </a:ext>
                  </a:extLst>
                </a:gridCol>
                <a:gridCol w="2363197">
                  <a:extLst>
                    <a:ext uri="{9D8B030D-6E8A-4147-A177-3AD203B41FA5}">
                      <a16:colId xmlns:a16="http://schemas.microsoft.com/office/drawing/2014/main" val="1718295044"/>
                    </a:ext>
                  </a:extLst>
                </a:gridCol>
                <a:gridCol w="575109">
                  <a:extLst>
                    <a:ext uri="{9D8B030D-6E8A-4147-A177-3AD203B41FA5}">
                      <a16:colId xmlns:a16="http://schemas.microsoft.com/office/drawing/2014/main" val="2742736700"/>
                    </a:ext>
                  </a:extLst>
                </a:gridCol>
                <a:gridCol w="816830">
                  <a:extLst>
                    <a:ext uri="{9D8B030D-6E8A-4147-A177-3AD203B41FA5}">
                      <a16:colId xmlns:a16="http://schemas.microsoft.com/office/drawing/2014/main" val="72269302"/>
                    </a:ext>
                  </a:extLst>
                </a:gridCol>
                <a:gridCol w="668655">
                  <a:extLst>
                    <a:ext uri="{9D8B030D-6E8A-4147-A177-3AD203B41FA5}">
                      <a16:colId xmlns:a16="http://schemas.microsoft.com/office/drawing/2014/main" val="1539627170"/>
                    </a:ext>
                  </a:extLst>
                </a:gridCol>
                <a:gridCol w="658368">
                  <a:extLst>
                    <a:ext uri="{9D8B030D-6E8A-4147-A177-3AD203B41FA5}">
                      <a16:colId xmlns:a16="http://schemas.microsoft.com/office/drawing/2014/main" val="2814864185"/>
                    </a:ext>
                  </a:extLst>
                </a:gridCol>
              </a:tblGrid>
              <a:tr h="415777">
                <a:tc>
                  <a:txBody>
                    <a:bodyPr/>
                    <a:lstStyle/>
                    <a:p>
                      <a:r>
                        <a:rPr lang="en-US" sz="1000" b="1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/>
                        <a:t>Gene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Revel</a:t>
                      </a:r>
                    </a:p>
                    <a:p>
                      <a:pPr algn="ctr"/>
                      <a:r>
                        <a:rPr lang="en-US" sz="1000" b="1" dirty="0"/>
                        <a:t>cut-of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Variant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P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FD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6423416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BMPR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Bone morphogenetic receptor type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7.20E-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8919367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BMPR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Bone morphogenetic receptor type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D-Mis on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7.20E-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3487007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TBX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T-box transcription factor 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7.20E-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0360322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GDF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Growth differentiation factor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7.20E-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6022700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GDF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Growth differentiation factor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D-Mis on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7.20E-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275787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KD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Kinase insert domain recep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3E-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318512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ACVR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ctivin receptor lik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3E-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6096768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SOX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RY box transcription factor 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.00E-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35E-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9002954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r>
                        <a:rPr lang="en-US" sz="1000" i="1" dirty="0"/>
                        <a:t>ACVR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ctivin receptor lik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D-Mis on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.30E-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4628522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pPr marL="11113" indent="0">
                        <a:tabLst/>
                      </a:pPr>
                      <a:r>
                        <a:rPr lang="en-US" sz="1000" i="1" dirty="0"/>
                        <a:t>COL6A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Collagen type VI alpha 5 ch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4.00E-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9947499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pPr marL="11113" indent="0">
                        <a:tabLst/>
                      </a:pPr>
                      <a:r>
                        <a:rPr lang="en-US" sz="1000" i="1" dirty="0"/>
                        <a:t>AQ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err="1"/>
                        <a:t>Aquaphorin</a:t>
                      </a:r>
                      <a:r>
                        <a:rPr lang="en-US" sz="1000" dirty="0"/>
                        <a:t>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50E-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5142396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pPr marL="11113" indent="0">
                        <a:tabLst/>
                      </a:pPr>
                      <a:r>
                        <a:rPr lang="en-US" sz="1000" i="1" dirty="0"/>
                        <a:t>ATP13A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TPase type 13A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LGD + D-M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.70E-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7094024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pPr marL="11113" indent="0">
                        <a:tabLst/>
                      </a:pPr>
                      <a:r>
                        <a:rPr lang="en-US" sz="1000" i="1" dirty="0"/>
                        <a:t>JPT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Jupiter microtubule-associated homolog 2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-Mis on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.80E-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3527603"/>
                  </a:ext>
                </a:extLst>
              </a:tr>
              <a:tr h="278092">
                <a:tc>
                  <a:txBody>
                    <a:bodyPr/>
                    <a:lstStyle/>
                    <a:p>
                      <a:pPr marL="11113" indent="0">
                        <a:tabLst/>
                      </a:pPr>
                      <a:r>
                        <a:rPr lang="en-US" sz="1000" i="1" dirty="0"/>
                        <a:t>FBLN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Fibulin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9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-Mis on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.40E-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.0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56570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53E5AA7-3396-5545-8173-09E5BFB14F21}"/>
              </a:ext>
            </a:extLst>
          </p:cNvPr>
          <p:cNvSpPr txBox="1"/>
          <p:nvPr/>
        </p:nvSpPr>
        <p:spPr>
          <a:xfrm>
            <a:off x="841366" y="5715620"/>
            <a:ext cx="97683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3. Gene-based association analysis using 2,789 European cases from all PAH subclasses and 18,819 European controls (11,101 SPARK parents, 7,718 NFE </a:t>
            </a:r>
            <a:r>
              <a:rPr lang="en-US" sz="1200" b="1" dirty="0" err="1"/>
              <a:t>gnomAD</a:t>
            </a:r>
            <a:r>
              <a:rPr lang="en-US" sz="1200" b="1" dirty="0"/>
              <a:t> v2.1.1). a) </a:t>
            </a:r>
            <a:r>
              <a:rPr lang="en-US" sz="1200" dirty="0"/>
              <a:t>Results of a binomial test confined to rare, likely gene damaging (LGD) and predicted deleterious missense (D-Mis) variants or D-Mis only variants in 20,000 protein-coding genes. Horizontal gray line indicates the Bonferroni-corrected threshold for significance. </a:t>
            </a:r>
            <a:r>
              <a:rPr lang="en-US" sz="1200" b="1" dirty="0"/>
              <a:t>b)</a:t>
            </a:r>
            <a:r>
              <a:rPr lang="en-US" sz="1200" dirty="0"/>
              <a:t> Complete list of top association genes (FDR&lt;0.1)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DBD46C-D446-B342-8502-A41636F2E782}"/>
              </a:ext>
            </a:extLst>
          </p:cNvPr>
          <p:cNvSpPr txBox="1"/>
          <p:nvPr/>
        </p:nvSpPr>
        <p:spPr>
          <a:xfrm>
            <a:off x="841366" y="1054381"/>
            <a:ext cx="3080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D0D05FF-3572-6A4B-9AB9-8DD6CF841139}"/>
              </a:ext>
            </a:extLst>
          </p:cNvPr>
          <p:cNvSpPr txBox="1"/>
          <p:nvPr/>
        </p:nvSpPr>
        <p:spPr>
          <a:xfrm>
            <a:off x="4746365" y="105438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1C4CD1-4E7D-4C4B-9F9B-57421387E9F5}"/>
              </a:ext>
            </a:extLst>
          </p:cNvPr>
          <p:cNvSpPr txBox="1"/>
          <p:nvPr/>
        </p:nvSpPr>
        <p:spPr>
          <a:xfrm>
            <a:off x="2049957" y="1056090"/>
            <a:ext cx="1673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ll European PAH cases</a:t>
            </a:r>
          </a:p>
        </p:txBody>
      </p:sp>
    </p:spTree>
    <p:extLst>
      <p:ext uri="{BB962C8B-B14F-4D97-AF65-F5344CB8AC3E}">
        <p14:creationId xmlns:p14="http://schemas.microsoft.com/office/powerpoint/2010/main" val="1836077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8A220B1-2F4F-6846-A38D-4D09E4B7EBD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94822" y="1231231"/>
            <a:ext cx="10002900" cy="3408008"/>
          </a:xfrm>
          <a:prstGeom prst="rect">
            <a:avLst/>
          </a:prstGeom>
        </p:spPr>
      </p:pic>
      <p:sp>
        <p:nvSpPr>
          <p:cNvPr id="6" name="Text Box 20">
            <a:extLst>
              <a:ext uri="{FF2B5EF4-FFF2-40B4-BE49-F238E27FC236}">
                <a16:creationId xmlns:a16="http://schemas.microsoft.com/office/drawing/2014/main" id="{4BB397C3-2561-0C40-A259-A0FE6ACCC579}"/>
              </a:ext>
            </a:extLst>
          </p:cNvPr>
          <p:cNvSpPr txBox="1"/>
          <p:nvPr/>
        </p:nvSpPr>
        <p:spPr>
          <a:xfrm>
            <a:off x="1094822" y="4967981"/>
            <a:ext cx="10002900" cy="766378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200" b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Fig. S</a:t>
            </a:r>
            <a:r>
              <a:rPr lang="en-US" sz="1200" b="1" dirty="0">
                <a:ea typeface="SimSu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. Power of detecting association of new risk genes by rare inherited variants.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The power analysis is based on sample size (~1800 IPAH cases, 20,000 controls), effect size (relative risk, RR) and cumulative allele frequency (CAF, the sum of allele frequency of rare deleterious variants in one gene in the population</a:t>
            </a:r>
            <a:r>
              <a:rPr lang="en-US" sz="1200" dirty="0">
                <a:ea typeface="SimSun" panose="02010600030101010101" pitchFamily="2" charset="-122"/>
                <a:cs typeface="Times New Roman" panose="02020603050405020304" pitchFamily="18" charset="0"/>
              </a:rPr>
              <a:t>). In each panel, different curves represent different RR given a type I error threshold of 2.5e-06 (genome-wide significance with Bonferroni correction). The range of 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CAF in the population</a:t>
            </a:r>
            <a:r>
              <a:rPr lang="en-US" sz="1200" dirty="0">
                <a:ea typeface="SimSun" panose="02010600030101010101" pitchFamily="2" charset="-122"/>
                <a:cs typeface="Times New Roman" panose="02020603050405020304" pitchFamily="18" charset="0"/>
              </a:rPr>
              <a:t> was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selected to match known PAH genes (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OX17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BMPR2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TBX4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) to represent a reasonable range. For genes with CAF similar to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BMPR2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or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TBX4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we have 80% power to detect genes with RR=5 or 3, respectively. For genes with CAF similar to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OX17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the lowest CAF among the three genes, we have 80% power to detect genes with RR=15. We note that recently identified risk genes,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OX17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KDR</a:t>
            </a:r>
            <a:r>
              <a:rPr lang="en-US" sz="12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, have RR=50 and 20, respectively. </a:t>
            </a:r>
          </a:p>
        </p:txBody>
      </p:sp>
    </p:spTree>
    <p:extLst>
      <p:ext uri="{BB962C8B-B14F-4D97-AF65-F5344CB8AC3E}">
        <p14:creationId xmlns:p14="http://schemas.microsoft.com/office/powerpoint/2010/main" val="5415130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E018B996-616C-D644-BFDD-BF8BC31067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3010" y="877163"/>
            <a:ext cx="2557618" cy="242413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A4301F5-1DD3-A846-80BA-64E30CF322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9010" y="3448238"/>
            <a:ext cx="2571905" cy="241653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E3EA9DE-34D4-A246-9251-9B56DF4A891A}"/>
              </a:ext>
            </a:extLst>
          </p:cNvPr>
          <p:cNvSpPr/>
          <p:nvPr/>
        </p:nvSpPr>
        <p:spPr>
          <a:xfrm>
            <a:off x="2932334" y="5971375"/>
            <a:ext cx="632733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ea typeface="DengXian" panose="02010600030101010101" pitchFamily="2" charset="-122"/>
              </a:rPr>
              <a:t>Fig S5.</a:t>
            </a:r>
            <a:r>
              <a:rPr lang="en-US" sz="1200" dirty="0">
                <a:ea typeface="DengXian" panose="02010600030101010101" pitchFamily="2" charset="-122"/>
              </a:rPr>
              <a:t> </a:t>
            </a:r>
            <a:r>
              <a:rPr lang="en-US" sz="1200" b="1" dirty="0">
                <a:ea typeface="DengXian" panose="02010600030101010101" pitchFamily="2" charset="-122"/>
              </a:rPr>
              <a:t>Depth of coding sequence coverage.</a:t>
            </a:r>
            <a:r>
              <a:rPr lang="en-US" sz="1200" dirty="0">
                <a:ea typeface="DengXian" panose="02010600030101010101" pitchFamily="2" charset="-122"/>
              </a:rPr>
              <a:t> Percentage of case and control samples with &gt;10X or &gt;15X coverage for novel PAH genes </a:t>
            </a:r>
            <a:r>
              <a:rPr lang="en-US" sz="1200" b="1" dirty="0">
                <a:ea typeface="DengXian" panose="02010600030101010101" pitchFamily="2" charset="-122"/>
              </a:rPr>
              <a:t>a)</a:t>
            </a:r>
            <a:r>
              <a:rPr lang="en-US" sz="1200" dirty="0">
                <a:ea typeface="DengXian" panose="02010600030101010101" pitchFamily="2" charset="-122"/>
              </a:rPr>
              <a:t> </a:t>
            </a:r>
            <a:r>
              <a:rPr lang="en-US" sz="1200" i="1" dirty="0">
                <a:ea typeface="DengXian" panose="02010600030101010101" pitchFamily="2" charset="-122"/>
              </a:rPr>
              <a:t>FBLN2</a:t>
            </a:r>
            <a:r>
              <a:rPr lang="en-US" sz="1200" dirty="0">
                <a:ea typeface="DengXian" panose="02010600030101010101" pitchFamily="2" charset="-122"/>
              </a:rPr>
              <a:t> and </a:t>
            </a:r>
            <a:r>
              <a:rPr lang="en-US" sz="1200" b="1" dirty="0">
                <a:ea typeface="DengXian" panose="02010600030101010101" pitchFamily="2" charset="-122"/>
              </a:rPr>
              <a:t>b)</a:t>
            </a:r>
            <a:r>
              <a:rPr lang="en-US" sz="1200" dirty="0">
                <a:ea typeface="DengXian" panose="02010600030101010101" pitchFamily="2" charset="-122"/>
              </a:rPr>
              <a:t> </a:t>
            </a:r>
            <a:r>
              <a:rPr lang="en-US" sz="1200" i="1" dirty="0">
                <a:ea typeface="DengXian" panose="02010600030101010101" pitchFamily="2" charset="-122"/>
              </a:rPr>
              <a:t>PDGFD</a:t>
            </a:r>
            <a:r>
              <a:rPr lang="en-US" sz="1200" dirty="0">
                <a:ea typeface="DengXian" panose="02010600030101010101" pitchFamily="2" charset="-122"/>
              </a:rPr>
              <a:t>. 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81387DC-0A58-5A49-9D14-DC035C316AE7}"/>
              </a:ext>
            </a:extLst>
          </p:cNvPr>
          <p:cNvSpPr txBox="1"/>
          <p:nvPr/>
        </p:nvSpPr>
        <p:spPr>
          <a:xfrm>
            <a:off x="3153286" y="847073"/>
            <a:ext cx="3080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232354-3B42-614D-A3AA-2A84C353163E}"/>
              </a:ext>
            </a:extLst>
          </p:cNvPr>
          <p:cNvSpPr txBox="1"/>
          <p:nvPr/>
        </p:nvSpPr>
        <p:spPr>
          <a:xfrm>
            <a:off x="3153286" y="342044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)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2DE32AA6-91CC-9C4B-966B-54EC740BBF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81404" y="881957"/>
            <a:ext cx="2552388" cy="2414549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A62F037-7928-D844-BCCE-73A347AA22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7940" y="3414704"/>
            <a:ext cx="2656078" cy="24836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90781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2FE6B55-C15B-0E49-86DC-5CC94E41A908}"/>
              </a:ext>
            </a:extLst>
          </p:cNvPr>
          <p:cNvGrpSpPr/>
          <p:nvPr/>
        </p:nvGrpSpPr>
        <p:grpSpPr>
          <a:xfrm>
            <a:off x="3800943" y="1418335"/>
            <a:ext cx="3810710" cy="3810710"/>
            <a:chOff x="1097698" y="2562309"/>
            <a:chExt cx="3810710" cy="381071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BE0D169-9B18-BD44-946F-5730090473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97698" y="2562309"/>
              <a:ext cx="3810710" cy="3810710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3BA74E8-B8E2-754A-8286-E7416D881F7A}"/>
                </a:ext>
              </a:extLst>
            </p:cNvPr>
            <p:cNvSpPr/>
            <p:nvPr/>
          </p:nvSpPr>
          <p:spPr>
            <a:xfrm>
              <a:off x="2941983" y="2690191"/>
              <a:ext cx="397565" cy="1855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69713EE3-E6B8-9049-BBF7-CE9261A8CCFF}"/>
              </a:ext>
            </a:extLst>
          </p:cNvPr>
          <p:cNvSpPr txBox="1"/>
          <p:nvPr/>
        </p:nvSpPr>
        <p:spPr>
          <a:xfrm>
            <a:off x="2240533" y="5285313"/>
            <a:ext cx="689001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6. Gene-based association analysis using 988 European APAH cases and 18,819 European controls (11,101 SPARK parents, 7,718 NFE </a:t>
            </a:r>
            <a:r>
              <a:rPr lang="en-US" sz="1200" b="1" dirty="0" err="1"/>
              <a:t>gnomAD</a:t>
            </a:r>
            <a:r>
              <a:rPr lang="en-US" sz="1200" b="1" dirty="0"/>
              <a:t> v2.1.1). </a:t>
            </a:r>
            <a:r>
              <a:rPr lang="en-US" sz="1200" dirty="0"/>
              <a:t>Results of a binomial test confined to rare, likely gene damaging (LGD) and predicted deleterious missense (D-Mis) variants or D-Mis only variants in 20,000 protein-coding genes. No genes met the Bonferroni-corrected threshold for significance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8C6981-CBE0-B14E-B59F-0C4CA5BBD55B}"/>
              </a:ext>
            </a:extLst>
          </p:cNvPr>
          <p:cNvSpPr txBox="1"/>
          <p:nvPr/>
        </p:nvSpPr>
        <p:spPr>
          <a:xfrm>
            <a:off x="4841703" y="1529282"/>
            <a:ext cx="1873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uropean APAH cases onl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BF22AF6-7C74-3B4A-8426-A817B72FE2FA}"/>
              </a:ext>
            </a:extLst>
          </p:cNvPr>
          <p:cNvSpPr txBox="1"/>
          <p:nvPr/>
        </p:nvSpPr>
        <p:spPr>
          <a:xfrm>
            <a:off x="6279782" y="1838563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ACVRL1</a:t>
            </a:r>
          </a:p>
        </p:txBody>
      </p:sp>
    </p:spTree>
    <p:extLst>
      <p:ext uri="{BB962C8B-B14F-4D97-AF65-F5344CB8AC3E}">
        <p14:creationId xmlns:p14="http://schemas.microsoft.com/office/powerpoint/2010/main" val="3735998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05</TotalTime>
  <Words>731</Words>
  <Application>Microsoft Macintosh PowerPoint</Application>
  <PresentationFormat>Widescreen</PresentationFormat>
  <Paragraphs>15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Welch, Carrie L.</dc:creator>
  <cp:keywords/>
  <dc:description/>
  <cp:lastModifiedBy>Welch, Carrie L.</cp:lastModifiedBy>
  <cp:revision>142</cp:revision>
  <dcterms:created xsi:type="dcterms:W3CDTF">2019-12-31T21:10:02Z</dcterms:created>
  <dcterms:modified xsi:type="dcterms:W3CDTF">2021-04-01T20:02:19Z</dcterms:modified>
  <cp:category/>
</cp:coreProperties>
</file>